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3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4660"/>
  </p:normalViewPr>
  <p:slideViewPr>
    <p:cSldViewPr snapToGrid="0">
      <p:cViewPr varScale="1">
        <p:scale>
          <a:sx n="57" d="100"/>
          <a:sy n="57" d="100"/>
        </p:scale>
        <p:origin x="72" y="3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3FC078-5547-442A-9389-62BA22F45EC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8BA5369-7A46-4EF2-BC91-D51AD22D1C3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A58A86-4937-4153-A21D-7F441EE195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649BB-CCC1-44CC-94F3-70ECAF2FB575}" type="datetimeFigureOut">
              <a:rPr lang="en-IN" smtClean="0"/>
              <a:t>25-09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FC5B4C-1F1F-48AD-8401-121F5A2DB7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1AD6CD-3608-42BE-A268-3F428E4AE5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91AAF-B4E4-4F4E-B7FC-CAD10366B7F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816597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CFC159-0806-4EBB-A13F-0AD4F3F4A9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25C5F9C-1055-4B13-AF41-97BB760456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230E44-CB77-4887-88F7-D988472AFD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649BB-CCC1-44CC-94F3-70ECAF2FB575}" type="datetimeFigureOut">
              <a:rPr lang="en-IN" smtClean="0"/>
              <a:t>25-09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B30CAE-FA02-48DF-8A40-02E323E6DA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532440-7729-4AFE-9679-B043526751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91AAF-B4E4-4F4E-B7FC-CAD10366B7F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955484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E8FAFE6-81F5-4442-AF23-8B97BC4A990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D96A76C-1C2A-4CAE-B039-BE21D092D16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AD40D3-4E72-4784-B63F-CC0297E0D6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649BB-CCC1-44CC-94F3-70ECAF2FB575}" type="datetimeFigureOut">
              <a:rPr lang="en-IN" smtClean="0"/>
              <a:t>25-09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4E0F96-E032-4F21-83A2-EEA9DC49CB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B9CED2-9675-4A87-AB11-67C6836DAB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91AAF-B4E4-4F4E-B7FC-CAD10366B7F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571064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D4F1BB-A4C8-4438-9AD3-7078637A0B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44279AB-7540-4F0B-80F6-BD22E6E8B0D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D2BC7C-7D30-454E-80F4-C2E01E43F3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649BB-CCC1-44CC-94F3-70ECAF2FB575}" type="datetimeFigureOut">
              <a:rPr lang="en-IN" smtClean="0"/>
              <a:t>25-09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FDDFF9-ABB3-4D2F-B57A-E3B477BEA3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F67B1B-5CEE-4D2E-A27B-F5ED33C8E5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91AAF-B4E4-4F4E-B7FC-CAD10366B7F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97187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D530E1-D630-4AA9-9199-3D1BC63994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DAE388-D3FE-413C-9944-0061C7BC03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58B422-5941-4CE6-898F-F623EFC75D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649BB-CCC1-44CC-94F3-70ECAF2FB575}" type="datetimeFigureOut">
              <a:rPr lang="en-IN" smtClean="0"/>
              <a:t>25-09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A62499-BE67-4604-BADE-B8E90CB8AD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0348E8-758F-4FF2-A2DA-3CCD67539E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91AAF-B4E4-4F4E-B7FC-CAD10366B7F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31133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3ED3DE-4576-4A28-8610-E62F6E800C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F1638A-8372-40E3-972C-A47299E1D39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340E062-642B-415C-B2F5-AB4CDCD527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642D37-0871-4A5F-8969-228E310DEB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649BB-CCC1-44CC-94F3-70ECAF2FB575}" type="datetimeFigureOut">
              <a:rPr lang="en-IN" smtClean="0"/>
              <a:t>25-09-2020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015D7EC-F018-443F-B82A-20603C3740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30277C-E6BA-493A-8769-CFDEE0A69D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91AAF-B4E4-4F4E-B7FC-CAD10366B7F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019504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616FA4-FABA-4647-A829-B08D7AAF9D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1AF36B-7A2F-4AD1-B3B2-CC1264BDD4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7CC1C14-839C-4011-B66D-C71A869171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F9977CC-C2A9-4810-818B-36B05CA11BA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85268B8-2DBB-414F-B5BC-5739771A8C9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52235A0-7784-4299-BA57-913B066FDF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649BB-CCC1-44CC-94F3-70ECAF2FB575}" type="datetimeFigureOut">
              <a:rPr lang="en-IN" smtClean="0"/>
              <a:t>25-09-2020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C294CDC-3D38-41E5-A4CB-D819BE492A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9654FB1-F785-438F-AB0E-CD42BF8029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91AAF-B4E4-4F4E-B7FC-CAD10366B7F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25115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6EE256-A016-4105-8FEE-C934563EC6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319D7B4-99D6-4EC4-BC8D-D6EE3D75E0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649BB-CCC1-44CC-94F3-70ECAF2FB575}" type="datetimeFigureOut">
              <a:rPr lang="en-IN" smtClean="0"/>
              <a:t>25-09-2020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9AA736A-5151-453B-B6C8-3A941D34DA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E1FEFA6-9463-499A-9D3A-AF51C2B345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91AAF-B4E4-4F4E-B7FC-CAD10366B7F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58861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A7D8BFE-003F-4B24-BA1A-E15CAF9E2B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649BB-CCC1-44CC-94F3-70ECAF2FB575}" type="datetimeFigureOut">
              <a:rPr lang="en-IN" smtClean="0"/>
              <a:t>25-09-2020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A7A4E2D-C6FC-4EF4-8FAB-184940DB9B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F3FD97B-9116-4D37-890F-469A595040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91AAF-B4E4-4F4E-B7FC-CAD10366B7F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439229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C468EF-C669-4E66-BB71-7C004FCADC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53C72E-5FBE-48D0-B78E-F3FD211472B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9275504-206B-42F3-9F99-DA54174D223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8DF82D-7EFD-400C-8652-A553F7A3E6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649BB-CCC1-44CC-94F3-70ECAF2FB575}" type="datetimeFigureOut">
              <a:rPr lang="en-IN" smtClean="0"/>
              <a:t>25-09-2020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E321B2E-9625-43AF-A14E-0265727154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1CD612-9F12-4DB0-AA19-D4D3F77953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91AAF-B4E4-4F4E-B7FC-CAD10366B7F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808706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D08CC0-20C6-4D6B-A991-1C337A715A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61105AB-EDCC-4022-8F13-9A1D1CED1AB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F93081B-0EF9-43D2-B514-38A90ED02E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E8D74A6-D849-419F-9CC2-1AC90AFF3E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649BB-CCC1-44CC-94F3-70ECAF2FB575}" type="datetimeFigureOut">
              <a:rPr lang="en-IN" smtClean="0"/>
              <a:t>25-09-2020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47A6D5A-3D79-466C-ADC6-78BA14DC04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52B21B7-D7B7-4927-8FD6-B2100FC6BB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91AAF-B4E4-4F4E-B7FC-CAD10366B7F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816798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72C4A6D-E1EB-409C-9415-2534E7FA7A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8F033E-245D-4D50-80C1-C0F640F688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BFFE3B-D8FB-454A-8D29-2FC38FCDB1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3649BB-CCC1-44CC-94F3-70ECAF2FB575}" type="datetimeFigureOut">
              <a:rPr lang="en-IN" smtClean="0"/>
              <a:t>25-09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45A493-7D4C-448B-9A71-9B56D6CBD8B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98A296-555C-4D9D-BD42-58F5E992A8B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691AAF-B4E4-4F4E-B7FC-CAD10366B7F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026154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853494E3-3B23-9A41-B40C-B501E10E9223}"/>
              </a:ext>
            </a:extLst>
          </p:cNvPr>
          <p:cNvSpPr/>
          <p:nvPr/>
        </p:nvSpPr>
        <p:spPr>
          <a:xfrm>
            <a:off x="0" y="0"/>
            <a:ext cx="12192000" cy="652544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b="1" u="sng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rt 1:  </a:t>
            </a:r>
            <a:r>
              <a:rPr lang="en-US" sz="1400" b="1" dirty="0">
                <a:solidFill>
                  <a:schemeClr val="accent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GTACC</a:t>
            </a:r>
            <a:r>
              <a:rPr lang="en-US" sz="1400" dirty="0">
                <a:solidFill>
                  <a:schemeClr val="accent1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ccggatcacactttgagaa</a:t>
            </a:r>
            <a:r>
              <a:rPr lang="en-US" sz="7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tgctgctttagtcttcctcccatctcctaaggccagagctcctgagtttgcttcccactggccaaggagaaaagagcaaggtcacttgtcggggggctgcagagggaattaccttctttcatttgcaaatgttactgggggacacaccggctcccagtagggtttccgccaaggctccgcgaaacgccactagagggcgccgctagcgaatcccacagcgcgccccgctgcccccacttttgtcctccgggttcacacgggcgcccggaagagagggtggtgcctgggagaggaaacgatgcgccccggggccgcggcctcattggatgagaggtcccacctcacggccc</a:t>
            </a:r>
            <a:r>
              <a:rPr lang="en-US" sz="7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aggcggggcttctttgcgcttaaaagccgagccgggccaatgttcaaat</a:t>
            </a:r>
            <a:r>
              <a:rPr lang="en-US" sz="7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CGCAGCTCTTAGTCGCGGGCCGACTGGTGTTTATCCGTCACTCGCCGAGGTTCCTTGGGTCATGGTGCCAGCCTGACTGAGAAGAGGACGCTCCCGGGAGACGAATGAGGAACCACCTCCTCCTACTGTTCAAGTACAGGGGCCTGGTCCGCAAAGGGAAGAAAAGCAAAAGACGAAA</a:t>
            </a:r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TG</a:t>
            </a:r>
            <a:r>
              <a:rPr lang="en-US" sz="7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CTAAATTCGTGATCCGCCCAGCCACTGCCGCCGACTGCAGTGACATACTGCGGCTGATCAAG</a:t>
            </a:r>
            <a:r>
              <a:rPr lang="en-US" sz="7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tagcggagagccagagctcctcccggggcgtggggtggaggtggctccgtttcccagagtggggtgattcacgtcttgaggtctcggccggtgtgagagcccagcctgttcccctttctgcgcccatccccggctcggccgccaccccgcccgcccgccccattccgttcccctgagctggccgggccggagcctcattttgttttctacttttttctctcctatgtgcatccccccagGAGCTGGCTAAATATGAATACATGGAAGAACAAGTAATCTTAACTGAAAAAGgtaattcaacagtggcgggacgggggacaagcgttcggtgcctgtcaccttcgccaaggccattaccgcccctgctcccccttcttgcag</a:t>
            </a:r>
            <a:r>
              <a:rPr lang="en-US" sz="7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TCTGCTAGAAGATGGTTTTGGAGAGCACCCCTTTTACCACTGCCTGGTTGCAGAAGTGCCGAAAGAGCACTGGACTCCGGAAGgtaacccctcgccctttccagaagccagagagaccaagtgttatgtaagaagtagtgtcggctgtgtagaaccactgactacacaggccgaagttactgagaacttggacagaaaaaatagccagcaagtgttcaaactactgaggaaaaaaaaaaattagatatgctgcacttaagaatactagggcaggttaaaagagctgtttaagtaagtatcagagtgctgtggagactcggaagtgtttaagctgcttaagtaagtataagtgctgtggagacccggaagagttagatataatgtcatttgttgtaattcagtttcataaaatggttcttgtttgaccctaacgtaacagtttttgtaattgtgttaaatcacatttttttctttaatttgtcccaatcttcaggttacagtctctagcttcgccatgtacatggcccttccgtgtacatggatgggcggggaggtaactaaaagatcctttacacaataaagtagatgatcatgataaatgaggtaaggtcctattatcacacacttcaaacacggtagatcagaaacccactatgatactcgcttcctgtctgtttgctaaggaatataaaatggctagaaagtttaatttgaaacctttgcctccatttggaatagtagacaccagttaagagggtgtcagatgccttttttttttttttttttttggctggtccctgttgattggtcagaagacagctcagctaaaaggggaagttgtctgggtggttgctttttttctgacgtctgttcctcaggctggaagaaatgagcagaaaacaagggatgagtactttttagagtatgtgcatgttacgtaatacctgtttctgggcaatgctgcttcttctgactcaacaaatggggagagcaaattgaaaatgcgtaaattggaaggcaagttctgaaattaaacgttgtactttggcctgatgttctgacctttaaggaagcaagagtttgtaaacttccaaatatttactattctgaactg</a:t>
            </a:r>
            <a:r>
              <a:rPr lang="en-US" sz="1400" b="1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cg</a:t>
            </a:r>
            <a:r>
              <a:rPr lang="en-US" sz="1400" dirty="0">
                <a:solidFill>
                  <a:srgbClr val="92D05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gtaaacctgacgtattccc</a:t>
            </a:r>
            <a:r>
              <a:rPr lang="en-US" sz="7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agtcaacataccagtataccaataggatgtgaataatgtgtgtgttgagtttaaaaccatagcagttttgctctggcaagtaatgaaagcgttctcgcttcctgagtgtgagctccag</a:t>
            </a:r>
            <a:r>
              <a:rPr lang="en-US" dirty="0">
                <a:solidFill>
                  <a:schemeClr val="accent1"/>
                </a:solidFill>
              </a:rPr>
              <a:t>cagactgcagagtggccagtc</a:t>
            </a:r>
            <a:r>
              <a:rPr lang="en-US" sz="1400" b="1" dirty="0">
                <a:solidFill>
                  <a:schemeClr val="accent2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TCGAG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b="1" u="sng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art  2A: </a:t>
            </a:r>
            <a:r>
              <a:rPr lang="en-US" sz="1400" b="1" dirty="0">
                <a:solidFill>
                  <a:schemeClr val="accent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TCGAG</a:t>
            </a:r>
            <a:r>
              <a:rPr lang="en-US" sz="1400" i="1" dirty="0">
                <a:solidFill>
                  <a:srgbClr val="7030A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TAACTTCGTATAGCATACATTATACGAAGTTAT</a:t>
            </a:r>
            <a:r>
              <a:rPr lang="en-US" dirty="0">
                <a:solidFill>
                  <a:schemeClr val="accent1"/>
                </a:solidFill>
              </a:rPr>
              <a:t>cacagttgtagcctgacttcagtg</a:t>
            </a:r>
            <a:r>
              <a:rPr lang="en-US" sz="7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gttctgatgtgtgctttttgcaaatacatgttctcagaacagtgagatcatccagcagtggcctggactgcactcacataaaaatcatgagacagccatggctacttgtttctgtaatacatgcatgtgtgttttttaaaacctatgataggcctctgattctgcagctgcaacttttatg</a:t>
            </a:r>
            <a:r>
              <a:rPr lang="en-US" sz="7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aatgttttccttctccacatctcatgtgatgctcttattacag</a:t>
            </a:r>
            <a:r>
              <a:rPr lang="en-US" sz="7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ACACAGCATTGTTGGTTTTGCCATGTACTATTTTACCTATGACCCGTGGATTGGCAAGTTATTGTATCTTGAGGACTTCTTCGTGATGAGTGATTAT</a:t>
            </a:r>
            <a:r>
              <a:rPr lang="en-US" sz="1400" dirty="0">
                <a:solidFill>
                  <a:schemeClr val="accent4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G</a:t>
            </a:r>
            <a:r>
              <a:rPr lang="en-US" sz="1400" dirty="0">
                <a:solidFill>
                  <a:schemeClr val="accent4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</a:t>
            </a:r>
            <a:r>
              <a:rPr lang="en-US" sz="7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</a:t>
            </a:r>
            <a:r>
              <a:rPr lang="en-US" sz="7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tacgattgagttcggagcagagggtctgaagagagttcagagttataaatgcttacaatgactttttaaattgtactctttctttttagGCTTTGGCATAGGATCAGAAATTCTGAAGAATCTAAGCCAG</a:t>
            </a:r>
            <a:r>
              <a:rPr lang="en-US" sz="7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tatgtcttagtttttggtttccaaatttgtaagtttactggattattttaatgatggaataaaaattgggtcttgagagcaggctgaaatgtcactgag</a:t>
            </a:r>
            <a:r>
              <a:rPr lang="en-US" sz="7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gtgtgttttactctctcataatag</a:t>
            </a:r>
            <a:r>
              <a:rPr lang="en-US" sz="7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TTGCAATGAGGTGTCGCTGCAGCAGCATGCACTTCTTGGTAGCAGAATGGAATGAACCATCCATCAACTTCTATAAAAGAAGAGGTGCTTCTGATCTGTCCAGTGAA</a:t>
            </a:r>
            <a:r>
              <a:rPr lang="en-US" sz="1400" dirty="0">
                <a:solidFill>
                  <a:schemeClr val="accent4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AG</a:t>
            </a:r>
            <a:r>
              <a:rPr lang="en-US" sz="7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GTTGGAGACTGTTCAAGATCGACAAGGAGTACTTGCTAAAAATGGCAACAGAGGAG</a:t>
            </a:r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GA</a:t>
            </a:r>
            <a:r>
              <a:rPr lang="en-US" sz="7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GAGTGCTGCTGTAGATGACAACCTCCATTCTATTTTAG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ATAAA</a:t>
            </a:r>
            <a:r>
              <a:rPr lang="en-US" sz="7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TCCCAACTTCTCTTGCTTTCTATGCTGTTTGTAGTGAAATAATAGAATGAGCACCCATTCCAAAGCTTTATTACCAGTGGCGTTGTTGCATGTTTGAAATGAGGTCTGTTTAAAGTGGCAATCTCAGATGCAGTTTGGAGAGTCAGATCTTTCTCCTTGAATATCTTTCGATAAACAACAAGGTGGTGTGATCTTAATATATTTGAAAAAAACTTCATTCTCGTGAGTCATTTAAATGTGTACAATGTACACACTGGTACTTAGAGTTTCTGTTTGATTCTTTTTTAATAAACTACTCTTTGATTTAATT</a:t>
            </a:r>
            <a:r>
              <a:rPr lang="en-US" dirty="0">
                <a:solidFill>
                  <a:schemeClr val="accent1"/>
                </a:solidFill>
              </a:rPr>
              <a:t>GTTTGGTGTAAGCAtttttactagttcttt</a:t>
            </a:r>
            <a:r>
              <a:rPr lang="en-US" sz="1400" b="1" dirty="0">
                <a:solidFill>
                  <a:schemeClr val="accent2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TCGAT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b="1" u="sng" dirty="0">
                <a:latin typeface="Arial" panose="020B0604020202020204" pitchFamily="34" charset="0"/>
                <a:cs typeface="Arial" panose="020B0604020202020204" pitchFamily="34" charset="0"/>
              </a:rPr>
              <a:t>Part 2B: </a:t>
            </a:r>
            <a:r>
              <a:rPr lang="en-US" sz="1400" b="1" dirty="0">
                <a:solidFill>
                  <a:schemeClr val="accent2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TCGAT</a:t>
            </a:r>
            <a:r>
              <a:rPr lang="en-US" sz="1400" i="1" dirty="0">
                <a:solidFill>
                  <a:srgbClr val="7030A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TAACTTCGTATAGCATACATTATACGAAGTTAT</a:t>
            </a:r>
            <a:r>
              <a:rPr lang="en-US" dirty="0">
                <a:solidFill>
                  <a:schemeClr val="accent1"/>
                </a:solidFill>
              </a:rPr>
              <a:t>cacagttgtagcctgacttcagtg</a:t>
            </a:r>
            <a:r>
              <a:rPr lang="en-US" sz="7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gttctgatgtgtgctttttgcaaatacatgttctcagaacagtgagatcatccagcagtggcctggactgcactcacataaaaatcatgagacagccatggctacttgtttctgtaatacatgcatgtgtgttttttaaaacctatgataggcctctgattctgcagctgcaacttttatg</a:t>
            </a:r>
            <a:r>
              <a:rPr lang="en-US" sz="7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aatgttttccttctccacatctcatgtgatgctcttattacag</a:t>
            </a:r>
            <a:r>
              <a:rPr lang="en-US" sz="7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ACACAGCATTGTTGGTTTTGCCATGTACTATTTTACCTATGACCCGTGGATTGGCAAGTTATTGTATCTTGAGGACTTCTTCGTGATGAGTGATTAT</a:t>
            </a:r>
            <a:r>
              <a:rPr lang="en-US" sz="1400" dirty="0">
                <a:solidFill>
                  <a:schemeClr val="accent4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CA</a:t>
            </a:r>
            <a:r>
              <a:rPr lang="en-US" sz="7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</a:t>
            </a:r>
            <a:r>
              <a:rPr lang="en-US" sz="7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tacgattgagttcggagcagagggtctgaagagagttcagagttataaatgcttacaatgactttttaaattgtactctttctttttagGCTTTGGCATAGGATCAGAAATTCTGAAGAATCTAAGCCAG</a:t>
            </a:r>
            <a:r>
              <a:rPr lang="en-US" sz="7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tatgtcttagtttttggtttccaaatttgtaagtttactggattattttaatgatggaataaaaattgggtcttgagagcaggctgaaatgtcactgag</a:t>
            </a:r>
            <a:r>
              <a:rPr lang="en-US" sz="7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gtgtgttttactctctcataatag</a:t>
            </a:r>
            <a:r>
              <a:rPr lang="en-US" sz="7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TTGCAATGAGGTGTCGCTGCAGCAGCATGCACTTCTTGGTAGCAGAATGGAATGAACCATCCATCAACTTCTATAAAAGAAGAGGTGCTTCTGATCTGTCCAGTGAA</a:t>
            </a:r>
            <a:r>
              <a:rPr lang="en-US" sz="1400" dirty="0">
                <a:solidFill>
                  <a:schemeClr val="accent4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AG</a:t>
            </a:r>
            <a:r>
              <a:rPr lang="en-US" sz="7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GTTGGAGACTGTTCAAGATCGACAAGGAGTACTTGCTAAAAATGGCAACAGAGGAG</a:t>
            </a:r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GA</a:t>
            </a:r>
            <a:r>
              <a:rPr lang="en-US" sz="7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GAGTGCTGCTGTAGATGACAACCTCCATTCTATTTTAG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ATAAA</a:t>
            </a:r>
            <a:r>
              <a:rPr lang="en-US" sz="7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TCCCAACTTCTCTTGCTTTCTATGCTGTTTGTAGTGAAATAATAGAATGAGCACCCATTCCAAAGCTTTATTACCAGTGGCGTTGTTGCATGTTTGAAATGAGGTCTGTTTAAAGTGGCAATCTCAGATGCAGTTTGGAGAGTCAGATCTTTCTCCTTGAATATCTTTCGATAAACAACAAGGTGGTGTGATCTTAATATATTTGAAAAAAACTTCATTCTCGTGAGTCATTTAAATGTGTACAATGTACACACTGGTACTTAGAGTTTCTGTTTGATTCTTTTTTAATAAACTACTCTTTGATTTAATT</a:t>
            </a:r>
            <a:r>
              <a:rPr lang="en-US" dirty="0">
                <a:solidFill>
                  <a:schemeClr val="accent1"/>
                </a:solidFill>
              </a:rPr>
              <a:t>GTTTGGTGTAAGCAtttttactagttcttt</a:t>
            </a:r>
            <a:r>
              <a:rPr lang="en-US" sz="1400" b="1" dirty="0">
                <a:solidFill>
                  <a:schemeClr val="accent2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AATTC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b="1" u="sng" dirty="0">
                <a:latin typeface="Arial" panose="020B0604020202020204" pitchFamily="34" charset="0"/>
                <a:cs typeface="Arial" panose="020B0604020202020204" pitchFamily="34" charset="0"/>
              </a:rPr>
              <a:t>Part 3: </a:t>
            </a:r>
            <a:r>
              <a:rPr lang="en-US" sz="1400" b="1" dirty="0">
                <a:solidFill>
                  <a:schemeClr val="accent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AATTC</a:t>
            </a:r>
            <a:r>
              <a:rPr lang="en-US" sz="1400" dirty="0">
                <a:solidFill>
                  <a:schemeClr val="accent1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ttcttacacatctttcttgctgt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</a:t>
            </a:r>
            <a:r>
              <a:rPr lang="en-US" sz="7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aagacaaaaatgacccgcaaacatcattggatgaacagaattgctcaaaatagtttttaacccaatttaaagtttttatggtcatgtgttatgttagtattaacaaagtctggatagaagccagtttaccagttggctatcaaggttttatacatagcaacatgtaaaacatgacttttttttttttttgagacacagtctcattctgttgctcaggctggagcgcagtagtacgatctcagctcactgcaacgtctgcctcccgggttcaagcaattctcatgcctcagcctcctgaatagctgggactataggcatgtgccaccgtacccagctgatttttgtatttttagtaaagacggggctttgccatgttggccacgctggtcttgaactcctgacctcaagtgatccacccacctcagcctaccgaagtgctgggatgacaagggtcagccacagcacccggcaaaacggctttttatgttgatgacactatacactgcatctgatggatttttttttttttttttttgagacagtctcgctttgtcacccagcctgggcagtgtggagtgcagtggcacgatctcggctcactgcaagctcctcctcctgggttcacaccattctcctgcctcagcctcctgaatagctgggactacaggcgcccgccaccatgcccggctaattttttgtattttttagtagagacggggtttcactgtgttagccaggatggtctcgatctcttgacctcataatccgcctgcctcggcctcccaaagtgctgggattacaggcatgagccactgcgcctggcctgacggaattttcaagagctgaaaaccaagttagaaactgaggcccacaatgaataaacccatcattacacaagtaaaatgtg</a:t>
            </a:r>
            <a:r>
              <a:rPr lang="en-US" sz="7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agatg</a:t>
            </a:r>
            <a:r>
              <a:rPr lang="en-US" dirty="0">
                <a:solidFill>
                  <a:schemeClr val="accent1"/>
                </a:solidFill>
              </a:rPr>
              <a:t>ggattatgaaacattgaaaatcaaga</a:t>
            </a:r>
            <a:r>
              <a:rPr lang="en-US" sz="1400" b="1" dirty="0">
                <a:solidFill>
                  <a:schemeClr val="accent2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CGGCCGC</a:t>
            </a:r>
            <a:endParaRPr lang="en-US" sz="1400" b="1" dirty="0">
              <a:solidFill>
                <a:schemeClr val="accent2"/>
              </a:solidFill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1">
            <a:extLst>
              <a:ext uri="{FF2B5EF4-FFF2-40B4-BE49-F238E27FC236}">
                <a16:creationId xmlns:a16="http://schemas.microsoft.com/office/drawing/2014/main" id="{AC573DA1-ECFE-9F43-81BB-7CF0AC20EADC}"/>
              </a:ext>
            </a:extLst>
          </p:cNvPr>
          <p:cNvSpPr txBox="1"/>
          <p:nvPr/>
        </p:nvSpPr>
        <p:spPr>
          <a:xfrm>
            <a:off x="90587" y="6413500"/>
            <a:ext cx="8810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: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 Parts of the SAT1 CRISPR/Cas9 gene editing construct. </a:t>
            </a:r>
          </a:p>
        </p:txBody>
      </p:sp>
    </p:spTree>
    <p:extLst>
      <p:ext uri="{BB962C8B-B14F-4D97-AF65-F5344CB8AC3E}">
        <p14:creationId xmlns:p14="http://schemas.microsoft.com/office/powerpoint/2010/main" val="32279167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200" y="282575"/>
            <a:ext cx="10515600" cy="4351338"/>
          </a:xfrm>
        </p:spPr>
        <p:txBody>
          <a:bodyPr>
            <a:normAutofit fontScale="55000" lnSpcReduction="20000"/>
          </a:bodyPr>
          <a:lstStyle/>
          <a:p>
            <a:pPr marL="0" indent="0">
              <a:buNone/>
            </a:pPr>
            <a:r>
              <a:rPr lang="en-US" b="1" dirty="0"/>
              <a:t>Supplementary Figure 2:</a:t>
            </a:r>
            <a:r>
              <a:rPr lang="en-US" dirty="0"/>
              <a:t>  Parts of the SAT1 CRISPR/Cas9 gene editing construct. </a:t>
            </a:r>
          </a:p>
          <a:p>
            <a:pPr marL="0" indent="0">
              <a:buNone/>
            </a:pPr>
            <a:r>
              <a:rPr lang="en-US" dirty="0"/>
              <a:t>Part 1: The orange colored sequences are restriction sequences of the </a:t>
            </a:r>
            <a:r>
              <a:rPr lang="en-US" dirty="0" err="1"/>
              <a:t>KpnI</a:t>
            </a:r>
            <a:r>
              <a:rPr lang="en-US" dirty="0"/>
              <a:t> and </a:t>
            </a:r>
            <a:r>
              <a:rPr lang="en-US" dirty="0" err="1"/>
              <a:t>XhoI</a:t>
            </a:r>
            <a:r>
              <a:rPr lang="en-US" dirty="0"/>
              <a:t> sites on the 5’ and 3’ ends. The </a:t>
            </a:r>
            <a:r>
              <a:rPr lang="en-US" dirty="0" err="1"/>
              <a:t>KpnI</a:t>
            </a:r>
            <a:r>
              <a:rPr lang="en-US" dirty="0"/>
              <a:t> sequence and the subsequent blue nucleotide sequences comprise the forward primer. The red colored ATG is the start codon of </a:t>
            </a:r>
            <a:r>
              <a:rPr lang="en-US" i="1" dirty="0"/>
              <a:t>SAT1</a:t>
            </a:r>
            <a:r>
              <a:rPr lang="en-US" dirty="0"/>
              <a:t>.  The PAM sequence (CCG sequence in red) and following gRNA sequence (in green) is present on the negative strand of the gene. The nucleotide sequences in blue color and attached </a:t>
            </a:r>
            <a:r>
              <a:rPr lang="en-US" dirty="0" err="1"/>
              <a:t>XhoI</a:t>
            </a:r>
            <a:r>
              <a:rPr lang="en-US" dirty="0"/>
              <a:t> site comprise the reverse primer.  Exons are capitalized.</a:t>
            </a:r>
          </a:p>
          <a:p>
            <a:pPr marL="0" indent="0">
              <a:buNone/>
            </a:pPr>
            <a:r>
              <a:rPr lang="en-US" dirty="0"/>
              <a:t>Part 2A: The orange colored sequences are restriction sequences of the </a:t>
            </a:r>
            <a:r>
              <a:rPr lang="en-US" dirty="0" err="1"/>
              <a:t>XhoI</a:t>
            </a:r>
            <a:r>
              <a:rPr lang="en-US" dirty="0"/>
              <a:t> and </a:t>
            </a:r>
            <a:r>
              <a:rPr lang="en-US" dirty="0" err="1"/>
              <a:t>ClaI</a:t>
            </a:r>
            <a:r>
              <a:rPr lang="en-US" dirty="0"/>
              <a:t> sites on the 5’ and 3’ ends.  The nucleotide sequence following the </a:t>
            </a:r>
            <a:r>
              <a:rPr lang="en-US" dirty="0" err="1"/>
              <a:t>XhoI</a:t>
            </a:r>
            <a:r>
              <a:rPr lang="en-US" dirty="0"/>
              <a:t> site in purple is the </a:t>
            </a:r>
            <a:r>
              <a:rPr lang="en-US" dirty="0" err="1"/>
              <a:t>LoxP</a:t>
            </a:r>
            <a:r>
              <a:rPr lang="en-US" dirty="0"/>
              <a:t> sequence.  The forward primer was composed of the </a:t>
            </a:r>
            <a:r>
              <a:rPr lang="en-US" dirty="0" err="1"/>
              <a:t>XhoI</a:t>
            </a:r>
            <a:r>
              <a:rPr lang="en-US" dirty="0"/>
              <a:t> site, the </a:t>
            </a:r>
            <a:r>
              <a:rPr lang="en-US" dirty="0" err="1"/>
              <a:t>LoxP</a:t>
            </a:r>
            <a:r>
              <a:rPr lang="en-US" dirty="0"/>
              <a:t> site, and 24 nucleotides of </a:t>
            </a:r>
            <a:r>
              <a:rPr lang="en-US" i="1" dirty="0"/>
              <a:t>SAT1</a:t>
            </a:r>
            <a:r>
              <a:rPr lang="en-US" dirty="0"/>
              <a:t> (blue). The restriction site on the 3’ end preceded by the blue sequence of </a:t>
            </a:r>
            <a:r>
              <a:rPr lang="en-US" i="1" dirty="0"/>
              <a:t>SAT1</a:t>
            </a:r>
            <a:r>
              <a:rPr lang="en-US" dirty="0"/>
              <a:t> constituted the reverse primer. The TGA codon in red is the termination codon of </a:t>
            </a:r>
            <a:r>
              <a:rPr lang="en-US" i="1" dirty="0"/>
              <a:t>SAT1</a:t>
            </a:r>
            <a:r>
              <a:rPr lang="en-US" dirty="0"/>
              <a:t>, and the polyadenylation signal sequence AAUAAA is indicated. Codons AGA and GAG in gold, encode the amino acids 101 (arginine) and 152 (glutamic acid).</a:t>
            </a:r>
          </a:p>
          <a:p>
            <a:pPr marL="0" indent="0">
              <a:buNone/>
            </a:pPr>
            <a:r>
              <a:rPr lang="en-US" dirty="0"/>
              <a:t>Part 2B: The sequences in orange are the restriction site sequences of </a:t>
            </a:r>
            <a:r>
              <a:rPr lang="en-US" dirty="0" err="1"/>
              <a:t>ClaI</a:t>
            </a:r>
            <a:r>
              <a:rPr lang="en-US" dirty="0"/>
              <a:t> and </a:t>
            </a:r>
            <a:r>
              <a:rPr lang="en-US" dirty="0" err="1"/>
              <a:t>EcoRI</a:t>
            </a:r>
            <a:r>
              <a:rPr lang="en-US" dirty="0"/>
              <a:t> ,and are part of respective forward and reverse primer sequences. The nucleotide sequence following enzyme restriction site in purple on 5’ end is the </a:t>
            </a:r>
            <a:r>
              <a:rPr lang="en-US" dirty="0" err="1"/>
              <a:t>LoxP</a:t>
            </a:r>
            <a:r>
              <a:rPr lang="en-US" dirty="0"/>
              <a:t> sequence, followed by a blue sequence of </a:t>
            </a:r>
            <a:r>
              <a:rPr lang="en-US" i="1" dirty="0"/>
              <a:t>SAT1</a:t>
            </a:r>
            <a:r>
              <a:rPr lang="en-US" dirty="0"/>
              <a:t>; all three were part of the forward primer. The restriction sequence on the 3’ end preceded by the blue colored sequence of </a:t>
            </a:r>
            <a:r>
              <a:rPr lang="en-US" i="1" dirty="0"/>
              <a:t>SAT1</a:t>
            </a:r>
            <a:r>
              <a:rPr lang="en-US" dirty="0"/>
              <a:t> constitute the reverse sequence. The TGA codon in red is the termination codon of </a:t>
            </a:r>
            <a:r>
              <a:rPr lang="en-US" i="1" dirty="0"/>
              <a:t>SAT1</a:t>
            </a:r>
            <a:r>
              <a:rPr lang="en-US" dirty="0"/>
              <a:t>. Codons GCA and AAG in gold encode the mutant amino acids 101 (alanine) and 152 (lysine).</a:t>
            </a:r>
          </a:p>
          <a:p>
            <a:pPr marL="0" indent="0">
              <a:buNone/>
            </a:pPr>
            <a:r>
              <a:rPr lang="en-US" dirty="0"/>
              <a:t>Part 3: The sequences in orange are restriction sequences of </a:t>
            </a:r>
            <a:r>
              <a:rPr lang="en-US" dirty="0" err="1"/>
              <a:t>EcoRI</a:t>
            </a:r>
            <a:r>
              <a:rPr lang="en-US" dirty="0"/>
              <a:t> on the 5’ and </a:t>
            </a:r>
            <a:r>
              <a:rPr lang="en-US" dirty="0" err="1"/>
              <a:t>NotI</a:t>
            </a:r>
            <a:r>
              <a:rPr lang="en-US" dirty="0"/>
              <a:t> on the 3’ ends, and are of part the respective forward and reverse primer sequences. The sequences in blue following the </a:t>
            </a:r>
            <a:r>
              <a:rPr lang="en-US" dirty="0" err="1"/>
              <a:t>EcoRI</a:t>
            </a:r>
            <a:r>
              <a:rPr lang="en-US" dirty="0"/>
              <a:t> and </a:t>
            </a:r>
            <a:r>
              <a:rPr lang="en-US" dirty="0" err="1"/>
              <a:t>NotI</a:t>
            </a:r>
            <a:r>
              <a:rPr lang="en-US" dirty="0"/>
              <a:t> restriction sequences are also part of respective primers.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680900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35</Words>
  <Application>Microsoft Office PowerPoint</Application>
  <PresentationFormat>Widescreen</PresentationFormat>
  <Paragraphs>1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yd off44</dc:creator>
  <cp:lastModifiedBy>hyd off44</cp:lastModifiedBy>
  <cp:revision>2</cp:revision>
  <dcterms:created xsi:type="dcterms:W3CDTF">2020-09-25T02:51:34Z</dcterms:created>
  <dcterms:modified xsi:type="dcterms:W3CDTF">2020-09-25T03:54:44Z</dcterms:modified>
</cp:coreProperties>
</file>